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69"/>
    <p:restoredTop sz="94746"/>
  </p:normalViewPr>
  <p:slideViewPr>
    <p:cSldViewPr snapToGrid="0" snapToObjects="1">
      <p:cViewPr>
        <p:scale>
          <a:sx n="50" d="100"/>
          <a:sy n="50" d="100"/>
        </p:scale>
        <p:origin x="152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3A13F4-B06E-E540-9C65-989A77B704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4B2710-3664-4445-BEA3-157707E676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6F783A-14B0-5346-9BAC-F58AA4B97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1BD424-DBE5-F24D-841E-D74600D86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ABDDA-CE2D-7A44-8552-9ED8DC386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151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0A1D7-EAE7-DA4C-AA35-93A57ADE0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770171-31EF-4948-801C-C0D7649BC3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2AF32-FB06-FB46-B05E-1FC0CEC34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4D4A1-7D42-F84C-A51F-DED7A0A59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87EABD-F699-144F-A76D-5C3863236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343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0043C5-A587-3146-BE6C-CF7404C4C1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E49126-2D66-C740-9123-E3D5D3BD5C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5A213-909D-F44B-82AB-C7D6E4830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31C412-8A6F-A24E-A0A8-596CEB81C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1B23DF-60B3-FF4E-A9ED-10151D639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857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1680-E1B0-364D-9B7C-6949212B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A27438-B599-6D4D-9C86-8002F99534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3A8E3D-15D3-074A-950D-C5E124744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6BB721-1011-B648-8833-9F87365E0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DD9C00-F5C2-AE4D-AD96-A66DA5DA2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90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198C89-C452-184A-AB17-9B47AE18F5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62CE84-ECCB-7D48-860F-1557D65D8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41E35-ADB8-C744-B8A6-EBEBE6001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FA4FBA-1884-7F4D-A2BA-6CBE2E29F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365E47-9EB3-424F-9ADD-1AC9878A9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79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D34F7-5549-9444-A289-54F4BDF00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9F0E22-59AC-544B-A477-E9662C7ED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A3CE7E-A6AB-8E4E-BFA3-890610B660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7074F7-8D74-9748-AF48-F4CBF38A9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9FDBF-A292-C140-BB60-065C6A24E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EACF54-2D0D-294D-AEEB-5E772337C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432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8DFD2-CDD9-4147-BEBF-2E98FB04D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01D080-EA6E-2749-B6BE-B64B4689FA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4570A9-FDE5-C043-93FE-562C09C811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8F7E6F-7B04-D448-A903-9185C6FABA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630069-0951-6240-A5F7-FFE7823521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03E25E-0058-C445-AE3D-3384D74AC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AC004F-FB0F-0448-8638-8BACF0B35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75B78E-487D-664D-A7C3-75591B70F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613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FA48B-BA5C-EB47-98EA-F051694DDD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CEEEB9-C393-FB4F-BDB7-282E07A4A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DCB8AE-A7CC-614C-9F03-2F7BF3488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6F5FF2-ED4D-B842-A8A7-71891C543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395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2961F2-0F2E-9A4A-8B10-2698A64FE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7C7D5B-548A-DF4E-B355-F5D7588A4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133C0F-C547-6A48-85C0-D55212BC2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12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5EC1D-9DEC-3243-B504-6E71CF0952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987FD8-C1A1-EF40-84C0-F24EB2A0DB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430643-6876-C64A-AA94-6EF346E8C8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8A1BE9-91A8-B742-9B70-3E4D75C0F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605D2-5EA2-E944-BD5D-E5F5FB104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1C715F-C659-184C-A30D-0B919A6F7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729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C5841-7521-D445-9305-ED28B8F186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44DFFC-1A1F-BD4C-96A9-9853145578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0DABDE-58D3-7943-8D9F-E983A02410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7C91F-82FB-6E47-98E9-D6FD1E961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8BCD6A-C454-4F41-8A21-7C4C42CF5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9A5BF0-66D0-F249-94A9-AAF6DE689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074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947336-9CBC-B34F-80CF-6AB6BD290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CAA83-67B0-4E48-AA38-BD486BD354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5C1357-D125-4D41-9821-095FC8477C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62589-FF43-4D40-A999-F8FB0FF26750}" type="datetimeFigureOut">
              <a:rPr lang="en-US" smtClean="0"/>
              <a:t>11/2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6CCF9F-AC0D-B84A-BEAA-B5C64D6FEA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448181-B817-B043-8458-824D236DA2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9AC3A-6E17-D144-8DD4-C09D164AFF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787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21BCE4D-0B73-4CB8-9D0C-0D52296A6BA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Posterior Reversible Encephalopathy Syndrome (PRES)</a:t>
            </a:r>
            <a:endParaRPr lang="en-US" dirty="0"/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99F7658A-921D-42D1-BCF8-EB7F2BDD6A6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  <a:p>
            <a:r>
              <a:rPr lang="en-US" dirty="0"/>
              <a:t>Simulation Stimuli</a:t>
            </a:r>
          </a:p>
        </p:txBody>
      </p:sp>
    </p:spTree>
    <p:extLst>
      <p:ext uri="{BB962C8B-B14F-4D97-AF65-F5344CB8AC3E}">
        <p14:creationId xmlns:p14="http://schemas.microsoft.com/office/powerpoint/2010/main" val="15940694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20AA7-D3DD-FD4D-9779-70D33C4C9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9. Chest X-Ray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B250317-E177-2D49-9155-20C95794C3FA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094892" y="1448972"/>
            <a:ext cx="6400800" cy="540902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36890D8-6808-4163-89CF-FA9CCD67EF89}"/>
              </a:ext>
            </a:extLst>
          </p:cNvPr>
          <p:cNvSpPr/>
          <p:nvPr/>
        </p:nvSpPr>
        <p:spPr>
          <a:xfrm>
            <a:off x="9793129" y="6311894"/>
            <a:ext cx="2232342" cy="5672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US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Author’s own image)</a:t>
            </a:r>
            <a:endParaRPr lang="en-US" dirty="0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58103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01104-B2C9-794E-B77B-AA60B4EDC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0. CT Head wo Contrast- Axial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42A8A355-F704-7A4E-8BAF-240A056F22B2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42714" y="1690689"/>
            <a:ext cx="5106572" cy="516731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E632749-1287-42CC-8D10-9FDBEE2D24F9}"/>
              </a:ext>
            </a:extLst>
          </p:cNvPr>
          <p:cNvSpPr/>
          <p:nvPr/>
        </p:nvSpPr>
        <p:spPr>
          <a:xfrm>
            <a:off x="9793129" y="6311894"/>
            <a:ext cx="2232342" cy="5672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US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Author’s own image)</a:t>
            </a:r>
            <a:endParaRPr lang="en-US" dirty="0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3833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7B496-AB58-1345-BC69-BA380C28F3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1. MRI Brain T2 FLAIR- Axial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EB6F9EBC-9B01-7543-8339-45616C1DC7CA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987040" y="1491176"/>
            <a:ext cx="6217920" cy="521911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461C0EB-1131-4B49-949A-0370B21ECC63}"/>
              </a:ext>
            </a:extLst>
          </p:cNvPr>
          <p:cNvSpPr/>
          <p:nvPr/>
        </p:nvSpPr>
        <p:spPr>
          <a:xfrm>
            <a:off x="9793129" y="6311894"/>
            <a:ext cx="2232342" cy="5672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US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Author’s own image)</a:t>
            </a:r>
            <a:endParaRPr lang="en-US" dirty="0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16767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32F4E-46FF-5A45-9043-DB5C41420C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2. MRI Brain T2 Flair- Coronal 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462BF584-1AB9-CF40-9E7C-7B107B0ECA8F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296529" y="1690688"/>
            <a:ext cx="5598941" cy="5167312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E745EBE-F01F-4A1D-8B00-C283AD31928C}"/>
              </a:ext>
            </a:extLst>
          </p:cNvPr>
          <p:cNvSpPr/>
          <p:nvPr/>
        </p:nvSpPr>
        <p:spPr>
          <a:xfrm>
            <a:off x="9793129" y="6311894"/>
            <a:ext cx="2232342" cy="5672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US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Author’s own image)</a:t>
            </a:r>
            <a:endParaRPr lang="en-US" dirty="0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4509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C315A-82D1-8C4D-8F1B-34B22E07C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9C5C9CE3-4E65-DA43-A2EB-E8C871A81D1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01102909"/>
              </p:ext>
            </p:extLst>
          </p:nvPr>
        </p:nvGraphicFramePr>
        <p:xfrm>
          <a:off x="3376246" y="2658794"/>
          <a:ext cx="5371673" cy="1430032"/>
        </p:xfrm>
        <a:graphic>
          <a:graphicData uri="http://schemas.openxmlformats.org/drawingml/2006/table">
            <a:tbl>
              <a:tblPr firstRow="1" firstCol="1" bandRow="1">
                <a:tableStyleId>{BC89EF96-8CEA-46FF-86C4-4CE0E7609802}</a:tableStyleId>
              </a:tblPr>
              <a:tblGrid>
                <a:gridCol w="3202745">
                  <a:extLst>
                    <a:ext uri="{9D8B030D-6E8A-4147-A177-3AD203B41FA5}">
                      <a16:colId xmlns:a16="http://schemas.microsoft.com/office/drawing/2014/main" val="2619751275"/>
                    </a:ext>
                  </a:extLst>
                </a:gridCol>
                <a:gridCol w="2168928">
                  <a:extLst>
                    <a:ext uri="{9D8B030D-6E8A-4147-A177-3AD203B41FA5}">
                      <a16:colId xmlns:a16="http://schemas.microsoft.com/office/drawing/2014/main" val="946669780"/>
                    </a:ext>
                  </a:extLst>
                </a:gridCol>
              </a:tblGrid>
              <a:tr h="14300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ln>
                            <a:noFill/>
                          </a:ln>
                        </a:rPr>
                        <a:t>Point of Care- Glucose</a:t>
                      </a:r>
                      <a:endParaRPr lang="en-US" sz="28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ln>
                            <a:noFill/>
                          </a:ln>
                        </a:rPr>
                        <a:t>110 mg/</a:t>
                      </a:r>
                      <a:r>
                        <a:rPr lang="en-US" sz="2800" dirty="0" err="1">
                          <a:ln>
                            <a:noFill/>
                          </a:ln>
                        </a:rPr>
                        <a:t>dL</a:t>
                      </a:r>
                      <a:endParaRPr lang="en-US" sz="2800" dirty="0">
                        <a:ln>
                          <a:noFill/>
                        </a:ln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976177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E91E9771-A71B-454C-A2AC-F8B1CAFA7D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-6547556" y="-1801099"/>
            <a:ext cx="1873955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.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4873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3BDB5-3BE5-2043-A5ED-87CBDF80C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2.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E187E47-13A3-3240-AD2B-D6E9B4388AB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63839180"/>
              </p:ext>
            </p:extLst>
          </p:nvPr>
        </p:nvGraphicFramePr>
        <p:xfrm>
          <a:off x="2712720" y="2236762"/>
          <a:ext cx="6766559" cy="3010487"/>
        </p:xfrm>
        <a:graphic>
          <a:graphicData uri="http://schemas.openxmlformats.org/drawingml/2006/table">
            <a:tbl>
              <a:tblPr firstRow="1" firstCol="1" bandRow="1">
                <a:tableStyleId>{FABFCF23-3B69-468F-B69F-88F6DE6A72F2}</a:tableStyleId>
              </a:tblPr>
              <a:tblGrid>
                <a:gridCol w="4059935">
                  <a:extLst>
                    <a:ext uri="{9D8B030D-6E8A-4147-A177-3AD203B41FA5}">
                      <a16:colId xmlns:a16="http://schemas.microsoft.com/office/drawing/2014/main" val="3141613739"/>
                    </a:ext>
                  </a:extLst>
                </a:gridCol>
                <a:gridCol w="2706624">
                  <a:extLst>
                    <a:ext uri="{9D8B030D-6E8A-4147-A177-3AD203B41FA5}">
                      <a16:colId xmlns:a16="http://schemas.microsoft.com/office/drawing/2014/main" val="1896436426"/>
                    </a:ext>
                  </a:extLst>
                </a:gridCol>
              </a:tblGrid>
              <a:tr h="5803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Complete Blood Count</a:t>
                      </a:r>
                      <a:endParaRPr lang="en-US" sz="2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 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851063047"/>
                  </a:ext>
                </a:extLst>
              </a:tr>
              <a:tr h="6891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White Blood Cell</a:t>
                      </a:r>
                      <a:endParaRPr lang="en-US" sz="2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6.8 x 10</a:t>
                      </a:r>
                      <a:r>
                        <a:rPr lang="en-US" sz="2800" baseline="30000">
                          <a:effectLst/>
                        </a:rPr>
                        <a:t>9</a:t>
                      </a:r>
                      <a:r>
                        <a:rPr lang="en-US" sz="2800">
                          <a:effectLst/>
                        </a:rPr>
                        <a:t>/µ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785855648"/>
                  </a:ext>
                </a:extLst>
              </a:tr>
              <a:tr h="5803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Hemoglobin</a:t>
                      </a:r>
                      <a:endParaRPr lang="en-US" sz="2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11.1 g/d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03605810"/>
                  </a:ext>
                </a:extLst>
              </a:tr>
              <a:tr h="5803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Hematocrit</a:t>
                      </a:r>
                      <a:endParaRPr lang="en-US" sz="2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0.39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903900011"/>
                  </a:ext>
                </a:extLst>
              </a:tr>
              <a:tr h="5803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Platelets</a:t>
                      </a:r>
                      <a:endParaRPr lang="en-US" sz="2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335 x 10</a:t>
                      </a:r>
                      <a:r>
                        <a:rPr lang="en-US" sz="2800" baseline="30000" dirty="0">
                          <a:effectLst/>
                        </a:rPr>
                        <a:t>9</a:t>
                      </a:r>
                      <a:r>
                        <a:rPr lang="en-US" sz="2800" dirty="0">
                          <a:effectLst/>
                        </a:rPr>
                        <a:t>/ µ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0387793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955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00A56-F28C-D842-BCFD-48DDA666C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thaiDist"/>
            <a:r>
              <a:rPr lang="en-US" dirty="0"/>
              <a:t>3. 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6C7516DC-9C22-E947-A2BE-7EAA3A2B0CD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66109689"/>
              </p:ext>
            </p:extLst>
          </p:nvPr>
        </p:nvGraphicFramePr>
        <p:xfrm>
          <a:off x="2958904" y="2124222"/>
          <a:ext cx="6274191" cy="3601329"/>
        </p:xfrm>
        <a:graphic>
          <a:graphicData uri="http://schemas.openxmlformats.org/drawingml/2006/table">
            <a:tbl>
              <a:tblPr firstRow="1" firstCol="1" bandRow="1">
                <a:tableStyleId>{B301B821-A1FF-4177-AEE7-76D212191A09}</a:tableStyleId>
              </a:tblPr>
              <a:tblGrid>
                <a:gridCol w="3764514">
                  <a:extLst>
                    <a:ext uri="{9D8B030D-6E8A-4147-A177-3AD203B41FA5}">
                      <a16:colId xmlns:a16="http://schemas.microsoft.com/office/drawing/2014/main" val="970670395"/>
                    </a:ext>
                  </a:extLst>
                </a:gridCol>
                <a:gridCol w="2509677">
                  <a:extLst>
                    <a:ext uri="{9D8B030D-6E8A-4147-A177-3AD203B41FA5}">
                      <a16:colId xmlns:a16="http://schemas.microsoft.com/office/drawing/2014/main" val="2855443609"/>
                    </a:ext>
                  </a:extLst>
                </a:gridCol>
              </a:tblGrid>
              <a:tr h="462473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Basic Metabolic Pane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 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83339366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Sodium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134 mEq/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767277374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Potassium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5.8 mEq/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103537142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Chloride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99 mEq/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881642166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Bicarbonate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26 mEq/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4124348214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Glucose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104 mg/d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85693896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BUN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8 mg/d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193109473"/>
                  </a:ext>
                </a:extLst>
              </a:tr>
              <a:tr h="44840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Creatinine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1.9 mg/</a:t>
                      </a:r>
                      <a:r>
                        <a:rPr lang="en-US" sz="2800" dirty="0" err="1">
                          <a:effectLst/>
                        </a:rPr>
                        <a:t>d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760323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529161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966E89-937F-E648-A6DB-25CF452B5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1D510230-1A50-EB44-9F30-30D09C92871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78351514"/>
              </p:ext>
            </p:extLst>
          </p:nvPr>
        </p:nvGraphicFramePr>
        <p:xfrm>
          <a:off x="1714500" y="1690688"/>
          <a:ext cx="8978900" cy="4059702"/>
        </p:xfrm>
        <a:graphic>
          <a:graphicData uri="http://schemas.openxmlformats.org/drawingml/2006/table">
            <a:tbl>
              <a:tblPr firstRow="1" firstCol="1" bandRow="1">
                <a:tableStyleId>{B301B821-A1FF-4177-AEE7-76D212191A09}</a:tableStyleId>
              </a:tblPr>
              <a:tblGrid>
                <a:gridCol w="6822595">
                  <a:extLst>
                    <a:ext uri="{9D8B030D-6E8A-4147-A177-3AD203B41FA5}">
                      <a16:colId xmlns:a16="http://schemas.microsoft.com/office/drawing/2014/main" val="2672529371"/>
                    </a:ext>
                  </a:extLst>
                </a:gridCol>
                <a:gridCol w="2156305">
                  <a:extLst>
                    <a:ext uri="{9D8B030D-6E8A-4147-A177-3AD203B41FA5}">
                      <a16:colId xmlns:a16="http://schemas.microsoft.com/office/drawing/2014/main" val="3089335547"/>
                    </a:ext>
                  </a:extLst>
                </a:gridCol>
              </a:tblGrid>
              <a:tr h="81065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Coagulopathy Pane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 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806954317"/>
                  </a:ext>
                </a:extLst>
              </a:tr>
              <a:tr h="117094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International Normalized Ratio (INR)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1.14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768933380"/>
                  </a:ext>
                </a:extLst>
              </a:tr>
              <a:tr h="90715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Prothrombin Time (PT)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27 seconds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341327419"/>
                  </a:ext>
                </a:extLst>
              </a:tr>
              <a:tr h="117094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Activated Partial </a:t>
                      </a:r>
                      <a:r>
                        <a:rPr lang="en-US" sz="2800" dirty="0" err="1">
                          <a:effectLst/>
                        </a:rPr>
                        <a:t>Thomboplastin</a:t>
                      </a:r>
                      <a:r>
                        <a:rPr lang="en-US" sz="2800" dirty="0">
                          <a:effectLst/>
                        </a:rPr>
                        <a:t> Time (</a:t>
                      </a:r>
                      <a:r>
                        <a:rPr lang="en-US" sz="2800" dirty="0" err="1">
                          <a:effectLst/>
                        </a:rPr>
                        <a:t>aPTT</a:t>
                      </a:r>
                      <a:r>
                        <a:rPr lang="en-US" sz="2800" dirty="0">
                          <a:effectLst/>
                        </a:rPr>
                        <a:t>)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11 seconds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38075413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01604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CF406-0D8E-A246-86F0-F7F92E468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. 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4E34DC5-BAFC-2749-B35D-6A74F65F862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66608767"/>
              </p:ext>
            </p:extLst>
          </p:nvPr>
        </p:nvGraphicFramePr>
        <p:xfrm>
          <a:off x="2825261" y="2222696"/>
          <a:ext cx="6541477" cy="3108958"/>
        </p:xfrm>
        <a:graphic>
          <a:graphicData uri="http://schemas.openxmlformats.org/drawingml/2006/table">
            <a:tbl>
              <a:tblPr firstRow="1" firstCol="1" bandRow="1">
                <a:tableStyleId>{B301B821-A1FF-4177-AEE7-76D212191A09}</a:tableStyleId>
              </a:tblPr>
              <a:tblGrid>
                <a:gridCol w="3924887">
                  <a:extLst>
                    <a:ext uri="{9D8B030D-6E8A-4147-A177-3AD203B41FA5}">
                      <a16:colId xmlns:a16="http://schemas.microsoft.com/office/drawing/2014/main" val="149320856"/>
                    </a:ext>
                  </a:extLst>
                </a:gridCol>
                <a:gridCol w="2616590">
                  <a:extLst>
                    <a:ext uri="{9D8B030D-6E8A-4147-A177-3AD203B41FA5}">
                      <a16:colId xmlns:a16="http://schemas.microsoft.com/office/drawing/2014/main" val="1006330996"/>
                    </a:ext>
                  </a:extLst>
                </a:gridCol>
              </a:tblGrid>
              <a:tr h="55332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Venous Blood Gas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 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686636138"/>
                  </a:ext>
                </a:extLst>
              </a:tr>
              <a:tr h="51112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pH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7.35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853995933"/>
                  </a:ext>
                </a:extLst>
              </a:tr>
              <a:tr h="51112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pCO2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40 mmHg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73154442"/>
                  </a:ext>
                </a:extLst>
              </a:tr>
              <a:tr h="51112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pO2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35 mmHg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557828867"/>
                  </a:ext>
                </a:extLst>
              </a:tr>
              <a:tr h="51112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HCO3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27 </a:t>
                      </a:r>
                      <a:r>
                        <a:rPr lang="en-US" sz="2800" dirty="0" err="1">
                          <a:effectLst/>
                        </a:rPr>
                        <a:t>mEq</a:t>
                      </a:r>
                      <a:r>
                        <a:rPr lang="en-US" sz="2800" dirty="0">
                          <a:effectLst/>
                        </a:rPr>
                        <a:t>/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48458511"/>
                  </a:ext>
                </a:extLst>
              </a:tr>
              <a:tr h="51112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Lactic Acid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1.3 </a:t>
                      </a:r>
                      <a:r>
                        <a:rPr lang="en-US" sz="2800" dirty="0" err="1">
                          <a:effectLst/>
                        </a:rPr>
                        <a:t>mEq</a:t>
                      </a:r>
                      <a:r>
                        <a:rPr lang="en-US" sz="2800" dirty="0">
                          <a:effectLst/>
                        </a:rPr>
                        <a:t>/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476070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537270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1F4D1-EEFF-634A-BA87-B33FDCCAC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.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9CC64A4-9E85-9D40-BA4E-5AFC8C39986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3944949"/>
              </p:ext>
            </p:extLst>
          </p:nvPr>
        </p:nvGraphicFramePr>
        <p:xfrm>
          <a:off x="3233224" y="2349305"/>
          <a:ext cx="5725551" cy="2377440"/>
        </p:xfrm>
        <a:graphic>
          <a:graphicData uri="http://schemas.openxmlformats.org/drawingml/2006/table">
            <a:tbl>
              <a:tblPr firstRow="1" firstCol="1" bandRow="1">
                <a:tableStyleId>{BDBED569-4797-4DF1-A0F4-6AAB3CD982D8}</a:tableStyleId>
              </a:tblPr>
              <a:tblGrid>
                <a:gridCol w="3435331">
                  <a:extLst>
                    <a:ext uri="{9D8B030D-6E8A-4147-A177-3AD203B41FA5}">
                      <a16:colId xmlns:a16="http://schemas.microsoft.com/office/drawing/2014/main" val="3881846605"/>
                    </a:ext>
                  </a:extLst>
                </a:gridCol>
                <a:gridCol w="2290220">
                  <a:extLst>
                    <a:ext uri="{9D8B030D-6E8A-4147-A177-3AD203B41FA5}">
                      <a16:colId xmlns:a16="http://schemas.microsoft.com/office/drawing/2014/main" val="1414874583"/>
                    </a:ext>
                  </a:extLst>
                </a:gridCol>
              </a:tblGrid>
              <a:tr h="86717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C-Reactive Protein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>
                          <a:effectLst/>
                        </a:rPr>
                        <a:t>5 mg/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05849791"/>
                  </a:ext>
                </a:extLst>
              </a:tr>
              <a:tr h="151026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1">
                          <a:effectLst/>
                        </a:rPr>
                        <a:t>Erythrocyte Sedimentation Rate</a:t>
                      </a:r>
                      <a:endParaRPr lang="en-US" sz="28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b="1" dirty="0">
                          <a:effectLst/>
                        </a:rPr>
                        <a:t>1 mm/Hg</a:t>
                      </a:r>
                      <a:endParaRPr lang="en-US" sz="2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126259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70051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4945F-15C3-964B-92E5-999A3DB826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.</a:t>
            </a:r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2B524E01-B96F-1947-8147-4FF95D8424B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27046195"/>
              </p:ext>
            </p:extLst>
          </p:nvPr>
        </p:nvGraphicFramePr>
        <p:xfrm>
          <a:off x="3416104" y="2813539"/>
          <a:ext cx="5359791" cy="1448971"/>
        </p:xfrm>
        <a:graphic>
          <a:graphicData uri="http://schemas.openxmlformats.org/drawingml/2006/table">
            <a:tbl>
              <a:tblPr firstRow="1" firstCol="1" bandRow="1">
                <a:tableStyleId>{BDBED569-4797-4DF1-A0F4-6AAB3CD982D8}</a:tableStyleId>
              </a:tblPr>
              <a:tblGrid>
                <a:gridCol w="3215874">
                  <a:extLst>
                    <a:ext uri="{9D8B030D-6E8A-4147-A177-3AD203B41FA5}">
                      <a16:colId xmlns:a16="http://schemas.microsoft.com/office/drawing/2014/main" val="297045188"/>
                    </a:ext>
                  </a:extLst>
                </a:gridCol>
                <a:gridCol w="2143917">
                  <a:extLst>
                    <a:ext uri="{9D8B030D-6E8A-4147-A177-3AD203B41FA5}">
                      <a16:colId xmlns:a16="http://schemas.microsoft.com/office/drawing/2014/main" val="2474011273"/>
                    </a:ext>
                  </a:extLst>
                </a:gridCol>
              </a:tblGrid>
              <a:tr h="144897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Troponin - I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dirty="0">
                          <a:effectLst/>
                        </a:rPr>
                        <a:t>0.06 ng/mL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8269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51756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99411-99FB-9042-9E7C-383F463622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. Electrocardiogram (ECG)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3467292-10EF-F042-984B-E3862FEBEB24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674055" y="1477108"/>
            <a:ext cx="9425354" cy="5380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0779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17</Words>
  <Application>Microsoft Office PowerPoint</Application>
  <PresentationFormat>Widescreen</PresentationFormat>
  <Paragraphs>74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sterior Reversible Encephalopathy Syndrome (PRES)</vt:lpstr>
      <vt:lpstr>1. </vt:lpstr>
      <vt:lpstr>2.</vt:lpstr>
      <vt:lpstr>3. </vt:lpstr>
      <vt:lpstr>4.</vt:lpstr>
      <vt:lpstr>5. </vt:lpstr>
      <vt:lpstr>6.</vt:lpstr>
      <vt:lpstr>7.</vt:lpstr>
      <vt:lpstr>8. Electrocardiogram (ECG) </vt:lpstr>
      <vt:lpstr>9. Chest X-Ray</vt:lpstr>
      <vt:lpstr>10. CT Head wo Contrast- Axial</vt:lpstr>
      <vt:lpstr>11. MRI Brain T2 FLAIR- Axial</vt:lpstr>
      <vt:lpstr>12. MRI Brain T2 Flair- Coronal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Ciozda</dc:creator>
  <cp:lastModifiedBy>Adeola Kosoko</cp:lastModifiedBy>
  <cp:revision>7</cp:revision>
  <dcterms:created xsi:type="dcterms:W3CDTF">2020-11-17T22:47:16Z</dcterms:created>
  <dcterms:modified xsi:type="dcterms:W3CDTF">2020-11-24T06:57:31Z</dcterms:modified>
</cp:coreProperties>
</file>